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2"/>
  </p:notesMasterIdLst>
  <p:sldIdLst>
    <p:sldId id="256" r:id="rId2"/>
    <p:sldId id="259" r:id="rId3"/>
    <p:sldId id="257" r:id="rId4"/>
    <p:sldId id="260" r:id="rId5"/>
    <p:sldId id="258" r:id="rId6"/>
    <p:sldId id="272" r:id="rId7"/>
    <p:sldId id="268" r:id="rId8"/>
    <p:sldId id="269" r:id="rId9"/>
    <p:sldId id="270" r:id="rId10"/>
    <p:sldId id="271" r:id="rId11"/>
    <p:sldId id="273" r:id="rId12"/>
    <p:sldId id="274" r:id="rId13"/>
    <p:sldId id="276" r:id="rId14"/>
    <p:sldId id="275" r:id="rId15"/>
    <p:sldId id="294" r:id="rId16"/>
    <p:sldId id="295" r:id="rId17"/>
    <p:sldId id="296" r:id="rId18"/>
    <p:sldId id="277" r:id="rId19"/>
    <p:sldId id="279" r:id="rId20"/>
    <p:sldId id="281" r:id="rId21"/>
    <p:sldId id="283" r:id="rId22"/>
    <p:sldId id="285" r:id="rId23"/>
    <p:sldId id="286" r:id="rId24"/>
    <p:sldId id="287" r:id="rId25"/>
    <p:sldId id="288" r:id="rId26"/>
    <p:sldId id="289" r:id="rId27"/>
    <p:sldId id="290" r:id="rId28"/>
    <p:sldId id="291" r:id="rId29"/>
    <p:sldId id="292" r:id="rId30"/>
    <p:sldId id="293" r:id="rId31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1045" autoAdjust="0"/>
    <p:restoredTop sz="94648"/>
  </p:normalViewPr>
  <p:slideViewPr>
    <p:cSldViewPr snapToGrid="0" snapToObjects="1">
      <p:cViewPr varScale="1">
        <p:scale>
          <a:sx n="107" d="100"/>
          <a:sy n="107" d="100"/>
        </p:scale>
        <p:origin x="1448" y="1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theme" Target="theme/theme1.xml"/><Relationship Id="rId8" Type="http://schemas.openxmlformats.org/officeDocument/2006/relationships/slide" Target="slides/slide7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1A54A8-DFC2-F446-B9A0-B9AA16686E69}" type="datetimeFigureOut">
              <a:rPr lang="en-US" smtClean="0"/>
              <a:t>4/1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575133-4295-194C-84C5-6845C6E8DD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3953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5575133-4295-194C-84C5-6845C6E8DDE5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15942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5575133-4295-194C-84C5-6845C6E8DDE5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15942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5575133-4295-194C-84C5-6845C6E8DDE5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15942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5575133-4295-194C-84C5-6845C6E8DDE5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15942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5575133-4295-194C-84C5-6845C6E8DDE5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15942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5575133-4295-194C-84C5-6845C6E8DDE5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15942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5575133-4295-194C-84C5-6845C6E8DDE5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1594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10785-7015-E34E-99A3-C3583938FC19}" type="datetimeFigureOut">
              <a:rPr lang="en-US" smtClean="0"/>
              <a:t>4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1D07D-3661-F242-AFA8-BE800C1B3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0372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10785-7015-E34E-99A3-C3583938FC19}" type="datetimeFigureOut">
              <a:rPr lang="en-US" smtClean="0"/>
              <a:t>4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1D07D-3661-F242-AFA8-BE800C1B3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63231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10785-7015-E34E-99A3-C3583938FC19}" type="datetimeFigureOut">
              <a:rPr lang="en-US" smtClean="0"/>
              <a:t>4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1D07D-3661-F242-AFA8-BE800C1B3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69000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10785-7015-E34E-99A3-C3583938FC19}" type="datetimeFigureOut">
              <a:rPr lang="en-US" smtClean="0"/>
              <a:t>4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1D07D-3661-F242-AFA8-BE800C1B3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88824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10785-7015-E34E-99A3-C3583938FC19}" type="datetimeFigureOut">
              <a:rPr lang="en-US" smtClean="0"/>
              <a:t>4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1D07D-3661-F242-AFA8-BE800C1B3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1364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10785-7015-E34E-99A3-C3583938FC19}" type="datetimeFigureOut">
              <a:rPr lang="en-US" smtClean="0"/>
              <a:t>4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1D07D-3661-F242-AFA8-BE800C1B3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19531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10785-7015-E34E-99A3-C3583938FC19}" type="datetimeFigureOut">
              <a:rPr lang="en-US" smtClean="0"/>
              <a:t>4/1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1D07D-3661-F242-AFA8-BE800C1B3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54341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10785-7015-E34E-99A3-C3583938FC19}" type="datetimeFigureOut">
              <a:rPr lang="en-US" smtClean="0"/>
              <a:t>4/1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1D07D-3661-F242-AFA8-BE800C1B3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17099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10785-7015-E34E-99A3-C3583938FC19}" type="datetimeFigureOut">
              <a:rPr lang="en-US" smtClean="0"/>
              <a:t>4/1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1D07D-3661-F242-AFA8-BE800C1B3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07132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10785-7015-E34E-99A3-C3583938FC19}" type="datetimeFigureOut">
              <a:rPr lang="en-US" smtClean="0"/>
              <a:t>4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1D07D-3661-F242-AFA8-BE800C1B3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37965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10785-7015-E34E-99A3-C3583938FC19}" type="datetimeFigureOut">
              <a:rPr lang="en-US" smtClean="0"/>
              <a:t>4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1D07D-3661-F242-AFA8-BE800C1B3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2389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410785-7015-E34E-99A3-C3583938FC19}" type="datetimeFigureOut">
              <a:rPr lang="en-US" smtClean="0"/>
              <a:t>4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C1D07D-3661-F242-AFA8-BE800C1B3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59210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tiff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tiff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Western Blots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032614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228600"/>
            <a:ext cx="9144000" cy="6390208"/>
          </a:xfrm>
          <a:prstGeom prst="rect">
            <a:avLst/>
          </a:prstGeom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605828" y="4188373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/>
              <a:t>Patient 1 STAT1</a:t>
            </a:r>
            <a:br>
              <a:rPr lang="en-US" dirty="0"/>
            </a:br>
            <a:r>
              <a:rPr lang="en-US" dirty="0"/>
              <a:t>10 mcg 07.6.2016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3A5E966-CAFC-7443-B5C4-36A7E905BD93}"/>
              </a:ext>
            </a:extLst>
          </p:cNvPr>
          <p:cNvSpPr txBox="1"/>
          <p:nvPr/>
        </p:nvSpPr>
        <p:spPr>
          <a:xfrm>
            <a:off x="308572" y="233179"/>
            <a:ext cx="30161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s 4B,D </a:t>
            </a:r>
          </a:p>
        </p:txBody>
      </p:sp>
      <p:sp>
        <p:nvSpPr>
          <p:cNvPr id="6" name="Frame 5">
            <a:extLst>
              <a:ext uri="{FF2B5EF4-FFF2-40B4-BE49-F238E27FC236}">
                <a16:creationId xmlns:a16="http://schemas.microsoft.com/office/drawing/2014/main" id="{C9FAAC4F-543F-1641-A577-6F08080FDC47}"/>
              </a:ext>
            </a:extLst>
          </p:cNvPr>
          <p:cNvSpPr/>
          <p:nvPr/>
        </p:nvSpPr>
        <p:spPr>
          <a:xfrm>
            <a:off x="1684811" y="2199498"/>
            <a:ext cx="1306286" cy="2030681"/>
          </a:xfrm>
          <a:prstGeom prst="fram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7" name="Frame 6">
            <a:extLst>
              <a:ext uri="{FF2B5EF4-FFF2-40B4-BE49-F238E27FC236}">
                <a16:creationId xmlns:a16="http://schemas.microsoft.com/office/drawing/2014/main" id="{EB3B9093-C26B-4E48-B9D1-B33E7654F28F}"/>
              </a:ext>
            </a:extLst>
          </p:cNvPr>
          <p:cNvSpPr/>
          <p:nvPr/>
        </p:nvSpPr>
        <p:spPr>
          <a:xfrm>
            <a:off x="3839688" y="2157692"/>
            <a:ext cx="1306286" cy="2030681"/>
          </a:xfrm>
          <a:prstGeom prst="fram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8" name="Frame 7">
            <a:extLst>
              <a:ext uri="{FF2B5EF4-FFF2-40B4-BE49-F238E27FC236}">
                <a16:creationId xmlns:a16="http://schemas.microsoft.com/office/drawing/2014/main" id="{6AA14252-D195-E343-9F63-8D5FD7B5E308}"/>
              </a:ext>
            </a:extLst>
          </p:cNvPr>
          <p:cNvSpPr/>
          <p:nvPr/>
        </p:nvSpPr>
        <p:spPr>
          <a:xfrm>
            <a:off x="5901542" y="2294500"/>
            <a:ext cx="1306286" cy="2030681"/>
          </a:xfrm>
          <a:prstGeom prst="fram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2054587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20160629_194651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1600" y="0"/>
            <a:ext cx="3857125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solidFill>
                  <a:srgbClr val="FF0000"/>
                </a:solidFill>
              </a:rPr>
              <a:t>Ponceau patient 6 06.29.2016</a:t>
            </a:r>
          </a:p>
        </p:txBody>
      </p:sp>
    </p:spTree>
    <p:extLst>
      <p:ext uri="{BB962C8B-B14F-4D97-AF65-F5344CB8AC3E}">
        <p14:creationId xmlns:p14="http://schemas.microsoft.com/office/powerpoint/2010/main" val="350510368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549400"/>
            <a:ext cx="9144000" cy="3746810"/>
          </a:xfrm>
          <a:prstGeom prst="rect">
            <a:avLst/>
          </a:prstGeom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605828" y="4188373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/>
              <a:t>Patient 6 pSTAT1+ Beta actin</a:t>
            </a:r>
            <a:br>
              <a:rPr lang="en-US" dirty="0"/>
            </a:br>
            <a:r>
              <a:rPr lang="en-US" dirty="0"/>
              <a:t>10 mcg 06.30.2016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216FA41-05D4-D24E-AE7B-5697F484A3F4}"/>
              </a:ext>
            </a:extLst>
          </p:cNvPr>
          <p:cNvSpPr txBox="1"/>
          <p:nvPr/>
        </p:nvSpPr>
        <p:spPr>
          <a:xfrm>
            <a:off x="308572" y="233179"/>
            <a:ext cx="30161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s 4B,C,D </a:t>
            </a:r>
          </a:p>
        </p:txBody>
      </p:sp>
      <p:sp>
        <p:nvSpPr>
          <p:cNvPr id="6" name="Frame 5">
            <a:extLst>
              <a:ext uri="{FF2B5EF4-FFF2-40B4-BE49-F238E27FC236}">
                <a16:creationId xmlns:a16="http://schemas.microsoft.com/office/drawing/2014/main" id="{FE183349-170E-9547-8AFA-F302354EBE3C}"/>
              </a:ext>
            </a:extLst>
          </p:cNvPr>
          <p:cNvSpPr/>
          <p:nvPr/>
        </p:nvSpPr>
        <p:spPr>
          <a:xfrm>
            <a:off x="2344386" y="1392124"/>
            <a:ext cx="2892632" cy="2030681"/>
          </a:xfrm>
          <a:prstGeom prst="fram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5569795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605828" y="4188373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/>
              <a:t>Patient 6 beta actin</a:t>
            </a:r>
            <a:br>
              <a:rPr lang="en-US" dirty="0"/>
            </a:br>
            <a:r>
              <a:rPr lang="en-US" dirty="0"/>
              <a:t>10 mcg 06.30.2016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125505"/>
            <a:ext cx="9144000" cy="306286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2FE3BF2-E177-FD4F-A21B-C8495092FB69}"/>
              </a:ext>
            </a:extLst>
          </p:cNvPr>
          <p:cNvSpPr txBox="1"/>
          <p:nvPr/>
        </p:nvSpPr>
        <p:spPr>
          <a:xfrm>
            <a:off x="379823" y="259400"/>
            <a:ext cx="35609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s 4B,C </a:t>
            </a:r>
          </a:p>
        </p:txBody>
      </p:sp>
      <p:sp>
        <p:nvSpPr>
          <p:cNvPr id="7" name="Frame 6">
            <a:extLst>
              <a:ext uri="{FF2B5EF4-FFF2-40B4-BE49-F238E27FC236}">
                <a16:creationId xmlns:a16="http://schemas.microsoft.com/office/drawing/2014/main" id="{405B9FB0-36F5-D94A-BD5A-FBCD37D62FCE}"/>
              </a:ext>
            </a:extLst>
          </p:cNvPr>
          <p:cNvSpPr/>
          <p:nvPr/>
        </p:nvSpPr>
        <p:spPr>
          <a:xfrm>
            <a:off x="1940625" y="1261496"/>
            <a:ext cx="3415146" cy="2030681"/>
          </a:xfrm>
          <a:prstGeom prst="fram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7443557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605828" y="4188373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/>
              <a:t>Patient 6 STAT1</a:t>
            </a:r>
            <a:br>
              <a:rPr lang="en-US" dirty="0"/>
            </a:br>
            <a:r>
              <a:rPr lang="en-US" dirty="0"/>
              <a:t>10 mcg 06.30.2016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184978"/>
            <a:ext cx="9144000" cy="300339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313D527-F5E7-1248-ADF2-0B1EEB45E6DF}"/>
              </a:ext>
            </a:extLst>
          </p:cNvPr>
          <p:cNvSpPr txBox="1"/>
          <p:nvPr/>
        </p:nvSpPr>
        <p:spPr>
          <a:xfrm>
            <a:off x="522328" y="428812"/>
            <a:ext cx="28056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s 4B,D </a:t>
            </a:r>
          </a:p>
        </p:txBody>
      </p:sp>
      <p:sp>
        <p:nvSpPr>
          <p:cNvPr id="6" name="Frame 5">
            <a:extLst>
              <a:ext uri="{FF2B5EF4-FFF2-40B4-BE49-F238E27FC236}">
                <a16:creationId xmlns:a16="http://schemas.microsoft.com/office/drawing/2014/main" id="{E82D2DEB-4575-F741-AD87-C6E2BD464CD0}"/>
              </a:ext>
            </a:extLst>
          </p:cNvPr>
          <p:cNvSpPr/>
          <p:nvPr/>
        </p:nvSpPr>
        <p:spPr>
          <a:xfrm>
            <a:off x="3235036" y="1014692"/>
            <a:ext cx="2690751" cy="2030681"/>
          </a:xfrm>
          <a:prstGeom prst="fram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698129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85DF6B-EC8A-EB48-8308-93F155CC23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atient 9 STAT1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BA9B9E9-1C62-5343-86ED-9F1D9564ED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595768"/>
            <a:ext cx="9144000" cy="517806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F995F16-3537-4E45-80A6-B90F73522BDB}"/>
              </a:ext>
            </a:extLst>
          </p:cNvPr>
          <p:cNvSpPr txBox="1"/>
          <p:nvPr/>
        </p:nvSpPr>
        <p:spPr>
          <a:xfrm>
            <a:off x="189817" y="781914"/>
            <a:ext cx="35609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s 4B,D </a:t>
            </a:r>
          </a:p>
        </p:txBody>
      </p:sp>
      <p:sp>
        <p:nvSpPr>
          <p:cNvPr id="6" name="Frame 5">
            <a:extLst>
              <a:ext uri="{FF2B5EF4-FFF2-40B4-BE49-F238E27FC236}">
                <a16:creationId xmlns:a16="http://schemas.microsoft.com/office/drawing/2014/main" id="{F3FAD1C4-3EB3-AF41-B512-811CEB96682E}"/>
              </a:ext>
            </a:extLst>
          </p:cNvPr>
          <p:cNvSpPr/>
          <p:nvPr/>
        </p:nvSpPr>
        <p:spPr>
          <a:xfrm>
            <a:off x="2213756" y="3149674"/>
            <a:ext cx="5030192" cy="1861714"/>
          </a:xfrm>
          <a:prstGeom prst="fram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4160429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1AE8F5-068E-CA41-A6FD-42AB9293B7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atient 9 actin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A2F7F04-122D-1A47-B75F-B274E86B5DD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500765"/>
            <a:ext cx="9144000" cy="517806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0B92259-00AA-8947-A85B-9C2CDE20F9BB}"/>
              </a:ext>
            </a:extLst>
          </p:cNvPr>
          <p:cNvSpPr txBox="1"/>
          <p:nvPr/>
        </p:nvSpPr>
        <p:spPr>
          <a:xfrm>
            <a:off x="379823" y="259400"/>
            <a:ext cx="35609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s 4B,C </a:t>
            </a:r>
          </a:p>
        </p:txBody>
      </p:sp>
      <p:sp>
        <p:nvSpPr>
          <p:cNvPr id="6" name="Frame 5">
            <a:extLst>
              <a:ext uri="{FF2B5EF4-FFF2-40B4-BE49-F238E27FC236}">
                <a16:creationId xmlns:a16="http://schemas.microsoft.com/office/drawing/2014/main" id="{FF08056C-2346-6B45-98A6-A7071D4B471E}"/>
              </a:ext>
            </a:extLst>
          </p:cNvPr>
          <p:cNvSpPr/>
          <p:nvPr/>
        </p:nvSpPr>
        <p:spPr>
          <a:xfrm>
            <a:off x="1988126" y="4827319"/>
            <a:ext cx="5089568" cy="2030681"/>
          </a:xfrm>
          <a:prstGeom prst="fram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2046651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EB4D99-9E6B-914C-A9B1-17B30AF6B2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atient 9 pSTAT1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808D4E5-6B51-2E41-9B90-798EA57F07C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172474"/>
            <a:ext cx="9144000" cy="517806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34FC0D7-4A6C-864B-8B30-E7E846A7A911}"/>
              </a:ext>
            </a:extLst>
          </p:cNvPr>
          <p:cNvSpPr txBox="1"/>
          <p:nvPr/>
        </p:nvSpPr>
        <p:spPr>
          <a:xfrm>
            <a:off x="379823" y="259400"/>
            <a:ext cx="35609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s 4C,D </a:t>
            </a:r>
          </a:p>
        </p:txBody>
      </p:sp>
      <p:sp>
        <p:nvSpPr>
          <p:cNvPr id="6" name="Frame 5">
            <a:extLst>
              <a:ext uri="{FF2B5EF4-FFF2-40B4-BE49-F238E27FC236}">
                <a16:creationId xmlns:a16="http://schemas.microsoft.com/office/drawing/2014/main" id="{38289C38-470B-A747-B3A2-1D931CD8B148}"/>
              </a:ext>
            </a:extLst>
          </p:cNvPr>
          <p:cNvSpPr/>
          <p:nvPr/>
        </p:nvSpPr>
        <p:spPr>
          <a:xfrm>
            <a:off x="1976251" y="3399055"/>
            <a:ext cx="4935188" cy="2030681"/>
          </a:xfrm>
          <a:prstGeom prst="fram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8760359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Patient 5 – 02.10.2017 </a:t>
            </a:r>
            <a:br>
              <a:rPr lang="en-US" dirty="0"/>
            </a:br>
            <a:r>
              <a:rPr lang="en-US" dirty="0"/>
              <a:t>STAT1 Cell Signaling 95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5066864" y="918678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9024" y="1812432"/>
            <a:ext cx="6742307" cy="471180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6CCE0E2-1E2C-424A-8DA8-58A90DBCCFF6}"/>
              </a:ext>
            </a:extLst>
          </p:cNvPr>
          <p:cNvSpPr txBox="1"/>
          <p:nvPr/>
        </p:nvSpPr>
        <p:spPr>
          <a:xfrm>
            <a:off x="325424" y="1721451"/>
            <a:ext cx="406250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s 4A,B and D </a:t>
            </a:r>
          </a:p>
          <a:p>
            <a:r>
              <a:rPr lang="en-US" dirty="0"/>
              <a:t>and 6C  left upper blot</a:t>
            </a:r>
          </a:p>
        </p:txBody>
      </p:sp>
      <p:sp>
        <p:nvSpPr>
          <p:cNvPr id="7" name="Frame 6">
            <a:extLst>
              <a:ext uri="{FF2B5EF4-FFF2-40B4-BE49-F238E27FC236}">
                <a16:creationId xmlns:a16="http://schemas.microsoft.com/office/drawing/2014/main" id="{6CA31EE6-778F-AE40-B1EB-DA22B15B2C67}"/>
              </a:ext>
            </a:extLst>
          </p:cNvPr>
          <p:cNvSpPr/>
          <p:nvPr/>
        </p:nvSpPr>
        <p:spPr>
          <a:xfrm>
            <a:off x="3102410" y="2169967"/>
            <a:ext cx="2333003" cy="1003255"/>
          </a:xfrm>
          <a:prstGeom prst="fram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90731109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Patient 5 – 02.10.2017 </a:t>
            </a:r>
            <a:br>
              <a:rPr lang="en-US" dirty="0"/>
            </a:br>
            <a:r>
              <a:rPr lang="en-US" dirty="0"/>
              <a:t>BA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5066864" y="918678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6815" y="1703630"/>
            <a:ext cx="6066725" cy="423968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C157761-F189-CC4B-8CC8-55140072CB60}"/>
              </a:ext>
            </a:extLst>
          </p:cNvPr>
          <p:cNvSpPr txBox="1"/>
          <p:nvPr/>
        </p:nvSpPr>
        <p:spPr>
          <a:xfrm>
            <a:off x="325424" y="1721451"/>
            <a:ext cx="406250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s 4A,B and C</a:t>
            </a:r>
          </a:p>
          <a:p>
            <a:r>
              <a:rPr lang="en-US" dirty="0"/>
              <a:t>6C left upper blot</a:t>
            </a:r>
          </a:p>
        </p:txBody>
      </p:sp>
      <p:sp>
        <p:nvSpPr>
          <p:cNvPr id="7" name="Frame 6">
            <a:extLst>
              <a:ext uri="{FF2B5EF4-FFF2-40B4-BE49-F238E27FC236}">
                <a16:creationId xmlns:a16="http://schemas.microsoft.com/office/drawing/2014/main" id="{BFFDA00B-01C1-4A45-B408-DCC76EA12BC5}"/>
              </a:ext>
            </a:extLst>
          </p:cNvPr>
          <p:cNvSpPr/>
          <p:nvPr/>
        </p:nvSpPr>
        <p:spPr>
          <a:xfrm>
            <a:off x="2694764" y="2723726"/>
            <a:ext cx="2180604" cy="1003255"/>
          </a:xfrm>
          <a:prstGeom prst="fram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169922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20160329_202517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1600" y="0"/>
            <a:ext cx="3857125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Ponceau patient 8 03.29.2017</a:t>
            </a:r>
          </a:p>
        </p:txBody>
      </p:sp>
    </p:spTree>
    <p:extLst>
      <p:ext uri="{BB962C8B-B14F-4D97-AF65-F5344CB8AC3E}">
        <p14:creationId xmlns:p14="http://schemas.microsoft.com/office/powerpoint/2010/main" val="2008755076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Patient 5 – 02.10.2017 </a:t>
            </a:r>
            <a:br>
              <a:rPr lang="en-US" dirty="0"/>
            </a:br>
            <a:r>
              <a:rPr lang="en-US" dirty="0"/>
              <a:t>membrane B - pSTAT1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5066864" y="918678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21327" y="2245191"/>
            <a:ext cx="5891074" cy="411692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910EB4A-9FAE-0346-9C09-CD8E439C6195}"/>
              </a:ext>
            </a:extLst>
          </p:cNvPr>
          <p:cNvSpPr txBox="1"/>
          <p:nvPr/>
        </p:nvSpPr>
        <p:spPr>
          <a:xfrm>
            <a:off x="325424" y="1721451"/>
            <a:ext cx="40625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4A, C and D </a:t>
            </a:r>
          </a:p>
        </p:txBody>
      </p:sp>
      <p:sp>
        <p:nvSpPr>
          <p:cNvPr id="7" name="Frame 6">
            <a:extLst>
              <a:ext uri="{FF2B5EF4-FFF2-40B4-BE49-F238E27FC236}">
                <a16:creationId xmlns:a16="http://schemas.microsoft.com/office/drawing/2014/main" id="{E68606E1-7592-CF4A-A5D2-5471153C866B}"/>
              </a:ext>
            </a:extLst>
          </p:cNvPr>
          <p:cNvSpPr/>
          <p:nvPr/>
        </p:nvSpPr>
        <p:spPr>
          <a:xfrm>
            <a:off x="3166999" y="2732640"/>
            <a:ext cx="2180604" cy="1003255"/>
          </a:xfrm>
          <a:prstGeom prst="fram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41651369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Patient 5 – 02.15.2017 </a:t>
            </a:r>
            <a:br>
              <a:rPr lang="en-US" dirty="0"/>
            </a:br>
            <a:r>
              <a:rPr lang="en-US" dirty="0"/>
              <a:t>STAT1 Cell Signaling 94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5066864" y="918678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94373" y="1417638"/>
            <a:ext cx="6188330" cy="432466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0EB443C-0E48-5A4B-9923-42A7847E2357}"/>
              </a:ext>
            </a:extLst>
          </p:cNvPr>
          <p:cNvSpPr txBox="1"/>
          <p:nvPr/>
        </p:nvSpPr>
        <p:spPr>
          <a:xfrm>
            <a:off x="140758" y="1687585"/>
            <a:ext cx="40625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7C right upper blot</a:t>
            </a:r>
          </a:p>
        </p:txBody>
      </p:sp>
      <p:sp>
        <p:nvSpPr>
          <p:cNvPr id="6" name="Frame 5">
            <a:extLst>
              <a:ext uri="{FF2B5EF4-FFF2-40B4-BE49-F238E27FC236}">
                <a16:creationId xmlns:a16="http://schemas.microsoft.com/office/drawing/2014/main" id="{47C1668D-77FA-FA4F-8023-048E90DF4642}"/>
              </a:ext>
            </a:extLst>
          </p:cNvPr>
          <p:cNvSpPr/>
          <p:nvPr/>
        </p:nvSpPr>
        <p:spPr>
          <a:xfrm>
            <a:off x="3976562" y="3091404"/>
            <a:ext cx="2180604" cy="1003255"/>
          </a:xfrm>
          <a:prstGeom prst="fram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06634583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Patient 5 – 02.15.2017 </a:t>
            </a:r>
            <a:br>
              <a:rPr lang="en-US" dirty="0"/>
            </a:br>
            <a:r>
              <a:rPr lang="en-US" dirty="0"/>
              <a:t>BA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5066864" y="918678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04768" y="1689825"/>
            <a:ext cx="6242678" cy="436264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18C1C21-DDF9-AE40-BFAA-BDFFED4429AF}"/>
              </a:ext>
            </a:extLst>
          </p:cNvPr>
          <p:cNvSpPr txBox="1"/>
          <p:nvPr/>
        </p:nvSpPr>
        <p:spPr>
          <a:xfrm>
            <a:off x="140758" y="1687585"/>
            <a:ext cx="40625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7C right upper blot</a:t>
            </a:r>
          </a:p>
        </p:txBody>
      </p:sp>
      <p:sp>
        <p:nvSpPr>
          <p:cNvPr id="6" name="Frame 5">
            <a:extLst>
              <a:ext uri="{FF2B5EF4-FFF2-40B4-BE49-F238E27FC236}">
                <a16:creationId xmlns:a16="http://schemas.microsoft.com/office/drawing/2014/main" id="{1479F67D-13DF-4847-846A-91FBDD7E0CE4}"/>
              </a:ext>
            </a:extLst>
          </p:cNvPr>
          <p:cNvSpPr/>
          <p:nvPr/>
        </p:nvSpPr>
        <p:spPr>
          <a:xfrm>
            <a:off x="3112962" y="2913786"/>
            <a:ext cx="2180604" cy="1003255"/>
          </a:xfrm>
          <a:prstGeom prst="fram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11596514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Patient 5 – 02.17.2017 </a:t>
            </a:r>
            <a:br>
              <a:rPr lang="en-US" dirty="0"/>
            </a:br>
            <a:r>
              <a:rPr lang="en-US" dirty="0"/>
              <a:t>STAT1 Cell Signaling 9172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5066864" y="918678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18652" y="1662664"/>
            <a:ext cx="5661376" cy="395640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97BDA50-CD21-1D4D-BB93-7FB62F62B487}"/>
              </a:ext>
            </a:extLst>
          </p:cNvPr>
          <p:cNvSpPr txBox="1"/>
          <p:nvPr/>
        </p:nvSpPr>
        <p:spPr>
          <a:xfrm>
            <a:off x="0" y="3091404"/>
            <a:ext cx="40625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7C right lower blot</a:t>
            </a:r>
          </a:p>
        </p:txBody>
      </p:sp>
      <p:sp>
        <p:nvSpPr>
          <p:cNvPr id="7" name="Frame 6">
            <a:extLst>
              <a:ext uri="{FF2B5EF4-FFF2-40B4-BE49-F238E27FC236}">
                <a16:creationId xmlns:a16="http://schemas.microsoft.com/office/drawing/2014/main" id="{A98D45E9-9059-954A-AF22-A8684DE5A496}"/>
              </a:ext>
            </a:extLst>
          </p:cNvPr>
          <p:cNvSpPr/>
          <p:nvPr/>
        </p:nvSpPr>
        <p:spPr>
          <a:xfrm>
            <a:off x="3070926" y="1752893"/>
            <a:ext cx="2180604" cy="1003255"/>
          </a:xfrm>
          <a:prstGeom prst="fram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18797649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Patient 5 – 02.17.2017 </a:t>
            </a:r>
            <a:br>
              <a:rPr lang="en-US" dirty="0"/>
            </a:br>
            <a:r>
              <a:rPr lang="en-US" dirty="0"/>
              <a:t>BA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5066864" y="918678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43071" y="1702398"/>
            <a:ext cx="7053074" cy="492898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197302E-51C1-8140-A0DF-C88574D2EBDC}"/>
              </a:ext>
            </a:extLst>
          </p:cNvPr>
          <p:cNvSpPr txBox="1"/>
          <p:nvPr/>
        </p:nvSpPr>
        <p:spPr>
          <a:xfrm>
            <a:off x="277500" y="1702398"/>
            <a:ext cx="4294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7C right lower blot</a:t>
            </a:r>
          </a:p>
        </p:txBody>
      </p:sp>
      <p:sp>
        <p:nvSpPr>
          <p:cNvPr id="7" name="Frame 6">
            <a:extLst>
              <a:ext uri="{FF2B5EF4-FFF2-40B4-BE49-F238E27FC236}">
                <a16:creationId xmlns:a16="http://schemas.microsoft.com/office/drawing/2014/main" id="{26552D66-B258-1B4F-8671-4DF8D72FA7AD}"/>
              </a:ext>
            </a:extLst>
          </p:cNvPr>
          <p:cNvSpPr/>
          <p:nvPr/>
        </p:nvSpPr>
        <p:spPr>
          <a:xfrm>
            <a:off x="3014132" y="2904360"/>
            <a:ext cx="2305130" cy="1003255"/>
          </a:xfrm>
          <a:prstGeom prst="fram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41340496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Patient 5 – 02.17.2017 </a:t>
            </a:r>
            <a:br>
              <a:rPr lang="en-US" dirty="0"/>
            </a:br>
            <a:r>
              <a:rPr lang="en-US" dirty="0"/>
              <a:t>STAT1 BD mouse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5066864" y="918678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86349" y="1579758"/>
            <a:ext cx="6999028" cy="489121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99D1B82-CC3A-7A4D-B331-0E99D8539BCE}"/>
              </a:ext>
            </a:extLst>
          </p:cNvPr>
          <p:cNvSpPr txBox="1"/>
          <p:nvPr/>
        </p:nvSpPr>
        <p:spPr>
          <a:xfrm>
            <a:off x="338666" y="3938071"/>
            <a:ext cx="45947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7C left lower blot</a:t>
            </a:r>
          </a:p>
        </p:txBody>
      </p:sp>
      <p:sp>
        <p:nvSpPr>
          <p:cNvPr id="6" name="Frame 5">
            <a:extLst>
              <a:ext uri="{FF2B5EF4-FFF2-40B4-BE49-F238E27FC236}">
                <a16:creationId xmlns:a16="http://schemas.microsoft.com/office/drawing/2014/main" id="{38C66229-354A-EC42-A9E1-A244CCD243B2}"/>
              </a:ext>
            </a:extLst>
          </p:cNvPr>
          <p:cNvSpPr/>
          <p:nvPr/>
        </p:nvSpPr>
        <p:spPr>
          <a:xfrm>
            <a:off x="3409593" y="2599560"/>
            <a:ext cx="2466274" cy="1003255"/>
          </a:xfrm>
          <a:prstGeom prst="fram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40618367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Patient 5 – 02.17.2017 </a:t>
            </a:r>
            <a:br>
              <a:rPr lang="en-US" dirty="0"/>
            </a:br>
            <a:r>
              <a:rPr lang="en-US" dirty="0"/>
              <a:t>BA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5066864" y="918678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91629" y="1736752"/>
            <a:ext cx="5458701" cy="381476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FEE47A3-A0DD-A247-84AF-C904FBA66035}"/>
              </a:ext>
            </a:extLst>
          </p:cNvPr>
          <p:cNvSpPr txBox="1"/>
          <p:nvPr/>
        </p:nvSpPr>
        <p:spPr>
          <a:xfrm>
            <a:off x="440265" y="4259804"/>
            <a:ext cx="45947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7C left lower blot</a:t>
            </a:r>
          </a:p>
        </p:txBody>
      </p:sp>
      <p:sp>
        <p:nvSpPr>
          <p:cNvPr id="6" name="Frame 5">
            <a:extLst>
              <a:ext uri="{FF2B5EF4-FFF2-40B4-BE49-F238E27FC236}">
                <a16:creationId xmlns:a16="http://schemas.microsoft.com/office/drawing/2014/main" id="{95C5DEA5-F576-1041-8571-E8EB33643D99}"/>
              </a:ext>
            </a:extLst>
          </p:cNvPr>
          <p:cNvSpPr/>
          <p:nvPr/>
        </p:nvSpPr>
        <p:spPr>
          <a:xfrm>
            <a:off x="3793067" y="2921293"/>
            <a:ext cx="1947334" cy="1003255"/>
          </a:xfrm>
          <a:prstGeom prst="fram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25124344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3FD2EA-AE3A-F043-881B-8F8226311C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STAT1 titration 1.19.2017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A32DDAF-DC83-3E43-A828-51BEC7998F6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073584"/>
            <a:ext cx="9144000" cy="271083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B8ACF58-FD6C-8040-BA24-ECFEAB02586C}"/>
              </a:ext>
            </a:extLst>
          </p:cNvPr>
          <p:cNvSpPr txBox="1"/>
          <p:nvPr/>
        </p:nvSpPr>
        <p:spPr>
          <a:xfrm>
            <a:off x="2714878" y="3860392"/>
            <a:ext cx="45947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6 B</a:t>
            </a:r>
          </a:p>
        </p:txBody>
      </p:sp>
      <p:sp>
        <p:nvSpPr>
          <p:cNvPr id="6" name="Frame 5">
            <a:extLst>
              <a:ext uri="{FF2B5EF4-FFF2-40B4-BE49-F238E27FC236}">
                <a16:creationId xmlns:a16="http://schemas.microsoft.com/office/drawing/2014/main" id="{2D788626-7705-9947-92FC-2A5DF35C6D88}"/>
              </a:ext>
            </a:extLst>
          </p:cNvPr>
          <p:cNvSpPr/>
          <p:nvPr/>
        </p:nvSpPr>
        <p:spPr>
          <a:xfrm>
            <a:off x="3471483" y="2694648"/>
            <a:ext cx="2466274" cy="509798"/>
          </a:xfrm>
          <a:prstGeom prst="fram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75945715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B628AF-0657-7B42-A9C3-9649F1CBBC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STAT1 titration 1.20.2017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54F7F00-55D3-2D4A-9825-0DF40B78599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1538" y="2452455"/>
            <a:ext cx="7400925" cy="319087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44503AC-40F1-844D-9EA3-FFCA4B5507D0}"/>
              </a:ext>
            </a:extLst>
          </p:cNvPr>
          <p:cNvSpPr txBox="1"/>
          <p:nvPr/>
        </p:nvSpPr>
        <p:spPr>
          <a:xfrm>
            <a:off x="1428245" y="5541236"/>
            <a:ext cx="45947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6 B</a:t>
            </a:r>
          </a:p>
        </p:txBody>
      </p:sp>
      <p:sp>
        <p:nvSpPr>
          <p:cNvPr id="6" name="Frame 5">
            <a:extLst>
              <a:ext uri="{FF2B5EF4-FFF2-40B4-BE49-F238E27FC236}">
                <a16:creationId xmlns:a16="http://schemas.microsoft.com/office/drawing/2014/main" id="{77B129F7-E6FF-E04B-94DE-B334A4B16513}"/>
              </a:ext>
            </a:extLst>
          </p:cNvPr>
          <p:cNvSpPr/>
          <p:nvPr/>
        </p:nvSpPr>
        <p:spPr>
          <a:xfrm>
            <a:off x="2443795" y="3914134"/>
            <a:ext cx="5632056" cy="509798"/>
          </a:xfrm>
          <a:prstGeom prst="fram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38378479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4F8EE4A-C365-3E46-9BD5-ED81DAD43A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1538" y="1976438"/>
            <a:ext cx="7400925" cy="2905125"/>
          </a:xfrm>
          <a:prstGeom prst="rect">
            <a:avLst/>
          </a:prstGeom>
        </p:spPr>
      </p:pic>
      <p:sp>
        <p:nvSpPr>
          <p:cNvPr id="6" name="Title 1">
            <a:extLst>
              <a:ext uri="{FF2B5EF4-FFF2-40B4-BE49-F238E27FC236}">
                <a16:creationId xmlns:a16="http://schemas.microsoft.com/office/drawing/2014/main" id="{E0C6E9E8-67C5-0A4C-B004-73B2E3EC99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1131094"/>
            <a:ext cx="7886700" cy="994172"/>
          </a:xfrm>
        </p:spPr>
        <p:txBody>
          <a:bodyPr/>
          <a:lstStyle/>
          <a:p>
            <a:pPr algn="ctr"/>
            <a:r>
              <a:rPr lang="en-US" dirty="0"/>
              <a:t>STAT1 titration 1.20.2017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74D2380-576C-0A48-AFF2-413827E63AEF}"/>
              </a:ext>
            </a:extLst>
          </p:cNvPr>
          <p:cNvSpPr txBox="1"/>
          <p:nvPr/>
        </p:nvSpPr>
        <p:spPr>
          <a:xfrm>
            <a:off x="2110636" y="3496250"/>
            <a:ext cx="48509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6 B</a:t>
            </a:r>
          </a:p>
        </p:txBody>
      </p:sp>
      <p:sp>
        <p:nvSpPr>
          <p:cNvPr id="7" name="Frame 6">
            <a:extLst>
              <a:ext uri="{FF2B5EF4-FFF2-40B4-BE49-F238E27FC236}">
                <a16:creationId xmlns:a16="http://schemas.microsoft.com/office/drawing/2014/main" id="{5B3E0F12-50FC-CE40-828D-EC578E2D412C}"/>
              </a:ext>
            </a:extLst>
          </p:cNvPr>
          <p:cNvSpPr/>
          <p:nvPr/>
        </p:nvSpPr>
        <p:spPr>
          <a:xfrm>
            <a:off x="2985961" y="2330506"/>
            <a:ext cx="2603838" cy="509798"/>
          </a:xfrm>
          <a:prstGeom prst="fram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859073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026" y="27020"/>
            <a:ext cx="9144000" cy="6390208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5828" y="4188373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/>
              <a:t>Patient 8 STAT1 + actin</a:t>
            </a:r>
            <a:br>
              <a:rPr lang="en-US" dirty="0"/>
            </a:br>
            <a:r>
              <a:rPr lang="en-US" dirty="0"/>
              <a:t>15 mcg 03.30.2016</a:t>
            </a:r>
          </a:p>
        </p:txBody>
      </p:sp>
      <p:cxnSp>
        <p:nvCxnSpPr>
          <p:cNvPr id="8" name="Straight Connector 7"/>
          <p:cNvCxnSpPr/>
          <p:nvPr/>
        </p:nvCxnSpPr>
        <p:spPr>
          <a:xfrm>
            <a:off x="1378187" y="3066764"/>
            <a:ext cx="7134144" cy="0"/>
          </a:xfrm>
          <a:prstGeom prst="line">
            <a:avLst/>
          </a:prstGeom>
          <a:ln>
            <a:prstDash val="dash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7E3C0D5A-E8CB-1F48-8561-148D772A557F}"/>
              </a:ext>
            </a:extLst>
          </p:cNvPr>
          <p:cNvSpPr txBox="1"/>
          <p:nvPr/>
        </p:nvSpPr>
        <p:spPr>
          <a:xfrm>
            <a:off x="605828" y="6047896"/>
            <a:ext cx="66268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wo part of the same gel/membrane were exposed at the same time</a:t>
            </a:r>
          </a:p>
        </p:txBody>
      </p:sp>
      <p:sp>
        <p:nvSpPr>
          <p:cNvPr id="4" name="Frame 3">
            <a:extLst>
              <a:ext uri="{FF2B5EF4-FFF2-40B4-BE49-F238E27FC236}">
                <a16:creationId xmlns:a16="http://schemas.microsoft.com/office/drawing/2014/main" id="{BCFA6CFA-960B-584A-8F3C-C69CE88CB869}"/>
              </a:ext>
            </a:extLst>
          </p:cNvPr>
          <p:cNvSpPr/>
          <p:nvPr/>
        </p:nvSpPr>
        <p:spPr>
          <a:xfrm>
            <a:off x="1235034" y="793874"/>
            <a:ext cx="3990109" cy="3386951"/>
          </a:xfrm>
          <a:prstGeom prst="fram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99E89E0-B766-5149-9367-8836E96C85FA}"/>
              </a:ext>
            </a:extLst>
          </p:cNvPr>
          <p:cNvSpPr txBox="1"/>
          <p:nvPr/>
        </p:nvSpPr>
        <p:spPr>
          <a:xfrm>
            <a:off x="605828" y="225631"/>
            <a:ext cx="30161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s 4B,C and D </a:t>
            </a:r>
          </a:p>
        </p:txBody>
      </p:sp>
    </p:spTree>
    <p:extLst>
      <p:ext uri="{BB962C8B-B14F-4D97-AF65-F5344CB8AC3E}">
        <p14:creationId xmlns:p14="http://schemas.microsoft.com/office/powerpoint/2010/main" val="3233777326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9CC9DF-0A82-A846-A7B2-2643942C24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Beta actin titration 3.25.2016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AF3ED9F-8CEC-CC43-B30B-5433EC185C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5272" y="2196935"/>
            <a:ext cx="7877191" cy="339621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B5456DD-32E0-024E-A7A8-66EA6B523E8C}"/>
              </a:ext>
            </a:extLst>
          </p:cNvPr>
          <p:cNvSpPr txBox="1"/>
          <p:nvPr/>
        </p:nvSpPr>
        <p:spPr>
          <a:xfrm>
            <a:off x="1636418" y="4184073"/>
            <a:ext cx="56650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6 A</a:t>
            </a:r>
          </a:p>
        </p:txBody>
      </p:sp>
      <p:sp>
        <p:nvSpPr>
          <p:cNvPr id="6" name="Frame 5">
            <a:extLst>
              <a:ext uri="{FF2B5EF4-FFF2-40B4-BE49-F238E27FC236}">
                <a16:creationId xmlns:a16="http://schemas.microsoft.com/office/drawing/2014/main" id="{E1C8BCEB-D486-154E-B172-7DC30ECD0CC9}"/>
              </a:ext>
            </a:extLst>
          </p:cNvPr>
          <p:cNvSpPr/>
          <p:nvPr/>
        </p:nvSpPr>
        <p:spPr>
          <a:xfrm>
            <a:off x="2888857" y="3018329"/>
            <a:ext cx="3040808" cy="509798"/>
          </a:xfrm>
          <a:prstGeom prst="fram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153075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28600"/>
            <a:ext cx="9144000" cy="6390208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5828" y="4188373"/>
            <a:ext cx="8229600" cy="1143000"/>
          </a:xfrm>
        </p:spPr>
        <p:txBody>
          <a:bodyPr>
            <a:normAutofit/>
          </a:bodyPr>
          <a:lstStyle/>
          <a:p>
            <a:r>
              <a:rPr lang="en-US" dirty="0"/>
              <a:t>Patient 8 STAT1 15 mcg 03.30.2016</a:t>
            </a:r>
          </a:p>
        </p:txBody>
      </p:sp>
    </p:spTree>
    <p:extLst>
      <p:ext uri="{BB962C8B-B14F-4D97-AF65-F5344CB8AC3E}">
        <p14:creationId xmlns:p14="http://schemas.microsoft.com/office/powerpoint/2010/main" val="165250897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rcRect t="10652" b="10652"/>
          <a:stretch>
            <a:fillRect/>
          </a:stretch>
        </p:blipFill>
        <p:spPr>
          <a:xfrm>
            <a:off x="457200" y="613971"/>
            <a:ext cx="8229600" cy="4525963"/>
          </a:xfrm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605828" y="4188373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/>
              <a:t>Patient 8 pSTAT1 + actin</a:t>
            </a:r>
            <a:br>
              <a:rPr lang="en-US" dirty="0"/>
            </a:br>
            <a:r>
              <a:rPr lang="en-US" dirty="0"/>
              <a:t>15 mcg 03.31.2016</a:t>
            </a:r>
          </a:p>
        </p:txBody>
      </p:sp>
      <p:sp>
        <p:nvSpPr>
          <p:cNvPr id="6" name="Frame 5">
            <a:extLst>
              <a:ext uri="{FF2B5EF4-FFF2-40B4-BE49-F238E27FC236}">
                <a16:creationId xmlns:a16="http://schemas.microsoft.com/office/drawing/2014/main" id="{E1DCC4E1-9E6D-1D4F-A245-2AE8EE400417}"/>
              </a:ext>
            </a:extLst>
          </p:cNvPr>
          <p:cNvSpPr/>
          <p:nvPr/>
        </p:nvSpPr>
        <p:spPr>
          <a:xfrm>
            <a:off x="937778" y="801422"/>
            <a:ext cx="3990109" cy="3386951"/>
          </a:xfrm>
          <a:prstGeom prst="fram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0AE4F8A-B1D7-5C4F-B2CF-E5E00F8B8270}"/>
              </a:ext>
            </a:extLst>
          </p:cNvPr>
          <p:cNvSpPr txBox="1"/>
          <p:nvPr/>
        </p:nvSpPr>
        <p:spPr>
          <a:xfrm>
            <a:off x="308572" y="233179"/>
            <a:ext cx="30161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s 4C, D </a:t>
            </a:r>
          </a:p>
        </p:txBody>
      </p:sp>
    </p:spTree>
    <p:extLst>
      <p:ext uri="{BB962C8B-B14F-4D97-AF65-F5344CB8AC3E}">
        <p14:creationId xmlns:p14="http://schemas.microsoft.com/office/powerpoint/2010/main" val="415729601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20160623_190613-2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1600" y="0"/>
            <a:ext cx="3857125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solidFill>
                  <a:srgbClr val="FF0000"/>
                </a:solidFill>
              </a:rPr>
              <a:t>Ponceau Patient 1 06.23.2016</a:t>
            </a:r>
          </a:p>
        </p:txBody>
      </p:sp>
    </p:spTree>
    <p:extLst>
      <p:ext uri="{BB962C8B-B14F-4D97-AF65-F5344CB8AC3E}">
        <p14:creationId xmlns:p14="http://schemas.microsoft.com/office/powerpoint/2010/main" val="174218810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228600"/>
            <a:ext cx="9144000" cy="6390208"/>
          </a:xfrm>
          <a:prstGeom prst="rect">
            <a:avLst/>
          </a:prstGeom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605828" y="4188373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/>
              <a:t>Patient 1 pSTAT1+ Beta actin</a:t>
            </a:r>
            <a:br>
              <a:rPr lang="en-US" dirty="0"/>
            </a:br>
            <a:r>
              <a:rPr lang="en-US" dirty="0"/>
              <a:t>10 mcg 06.24.2016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F84C82E-07E4-094C-9DCC-6DAB1A35E3CA}"/>
              </a:ext>
            </a:extLst>
          </p:cNvPr>
          <p:cNvSpPr txBox="1"/>
          <p:nvPr/>
        </p:nvSpPr>
        <p:spPr>
          <a:xfrm>
            <a:off x="308572" y="233179"/>
            <a:ext cx="30161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s 4B,C,D </a:t>
            </a:r>
          </a:p>
        </p:txBody>
      </p:sp>
      <p:sp>
        <p:nvSpPr>
          <p:cNvPr id="2" name="Frame 1">
            <a:extLst>
              <a:ext uri="{FF2B5EF4-FFF2-40B4-BE49-F238E27FC236}">
                <a16:creationId xmlns:a16="http://schemas.microsoft.com/office/drawing/2014/main" id="{BAF4E5A5-D2A8-5943-8495-5242ACE5CF8F}"/>
              </a:ext>
            </a:extLst>
          </p:cNvPr>
          <p:cNvSpPr/>
          <p:nvPr/>
        </p:nvSpPr>
        <p:spPr>
          <a:xfrm>
            <a:off x="961901" y="1543792"/>
            <a:ext cx="1306286" cy="2030681"/>
          </a:xfrm>
          <a:prstGeom prst="fram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7" name="Frame 6">
            <a:extLst>
              <a:ext uri="{FF2B5EF4-FFF2-40B4-BE49-F238E27FC236}">
                <a16:creationId xmlns:a16="http://schemas.microsoft.com/office/drawing/2014/main" id="{35BAB197-DAB5-294C-8078-F37AA4B66291}"/>
              </a:ext>
            </a:extLst>
          </p:cNvPr>
          <p:cNvSpPr/>
          <p:nvPr/>
        </p:nvSpPr>
        <p:spPr>
          <a:xfrm>
            <a:off x="3085605" y="1543791"/>
            <a:ext cx="1306286" cy="2030681"/>
          </a:xfrm>
          <a:prstGeom prst="fram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8" name="Frame 7">
            <a:extLst>
              <a:ext uri="{FF2B5EF4-FFF2-40B4-BE49-F238E27FC236}">
                <a16:creationId xmlns:a16="http://schemas.microsoft.com/office/drawing/2014/main" id="{F6AEA9CA-7D47-9944-9CEF-6E2D8E2F2F04}"/>
              </a:ext>
            </a:extLst>
          </p:cNvPr>
          <p:cNvSpPr/>
          <p:nvPr/>
        </p:nvSpPr>
        <p:spPr>
          <a:xfrm>
            <a:off x="5138057" y="1470211"/>
            <a:ext cx="1306286" cy="2030681"/>
          </a:xfrm>
          <a:prstGeom prst="fram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69645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228600"/>
            <a:ext cx="9144000" cy="6390208"/>
          </a:xfrm>
          <a:prstGeom prst="rect">
            <a:avLst/>
          </a:prstGeom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605828" y="4188373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/>
              <a:t>Patient 1 pSTAT1</a:t>
            </a:r>
            <a:br>
              <a:rPr lang="en-US" dirty="0"/>
            </a:br>
            <a:r>
              <a:rPr lang="en-US" dirty="0"/>
              <a:t>10 mcg 06.24.2016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9F92AE2-BBD0-3446-BD9D-718D1B5A7770}"/>
              </a:ext>
            </a:extLst>
          </p:cNvPr>
          <p:cNvSpPr txBox="1"/>
          <p:nvPr/>
        </p:nvSpPr>
        <p:spPr>
          <a:xfrm>
            <a:off x="308572" y="233179"/>
            <a:ext cx="30161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s 4C,D </a:t>
            </a:r>
          </a:p>
        </p:txBody>
      </p:sp>
      <p:sp>
        <p:nvSpPr>
          <p:cNvPr id="6" name="Frame 5">
            <a:extLst>
              <a:ext uri="{FF2B5EF4-FFF2-40B4-BE49-F238E27FC236}">
                <a16:creationId xmlns:a16="http://schemas.microsoft.com/office/drawing/2014/main" id="{FD3926F7-D661-D747-93EB-0BA2099A400E}"/>
              </a:ext>
            </a:extLst>
          </p:cNvPr>
          <p:cNvSpPr/>
          <p:nvPr/>
        </p:nvSpPr>
        <p:spPr>
          <a:xfrm>
            <a:off x="753093" y="1380101"/>
            <a:ext cx="1306286" cy="2030681"/>
          </a:xfrm>
          <a:prstGeom prst="fram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7" name="Frame 6">
            <a:extLst>
              <a:ext uri="{FF2B5EF4-FFF2-40B4-BE49-F238E27FC236}">
                <a16:creationId xmlns:a16="http://schemas.microsoft.com/office/drawing/2014/main" id="{CD87FD36-1727-0B4A-9ECA-B2CEDEFA93CB}"/>
              </a:ext>
            </a:extLst>
          </p:cNvPr>
          <p:cNvSpPr/>
          <p:nvPr/>
        </p:nvSpPr>
        <p:spPr>
          <a:xfrm>
            <a:off x="2979222" y="1397913"/>
            <a:ext cx="1306286" cy="2030681"/>
          </a:xfrm>
          <a:prstGeom prst="fram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8" name="Frame 7">
            <a:extLst>
              <a:ext uri="{FF2B5EF4-FFF2-40B4-BE49-F238E27FC236}">
                <a16:creationId xmlns:a16="http://schemas.microsoft.com/office/drawing/2014/main" id="{83CBBE3B-C737-2A45-BC2E-4A4110BE041C}"/>
              </a:ext>
            </a:extLst>
          </p:cNvPr>
          <p:cNvSpPr/>
          <p:nvPr/>
        </p:nvSpPr>
        <p:spPr>
          <a:xfrm>
            <a:off x="5034643" y="1423272"/>
            <a:ext cx="1306286" cy="2030681"/>
          </a:xfrm>
          <a:prstGeom prst="fram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2809209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228600"/>
            <a:ext cx="9144000" cy="6390208"/>
          </a:xfrm>
          <a:prstGeom prst="rect">
            <a:avLst/>
          </a:prstGeom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605828" y="4188373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/>
              <a:t>Patient 1 Beta actin</a:t>
            </a:r>
            <a:br>
              <a:rPr lang="en-US" dirty="0"/>
            </a:br>
            <a:r>
              <a:rPr lang="en-US" dirty="0"/>
              <a:t>10 mcg 06.24.2016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64B99D0-DC11-D346-8FCE-EF81DA4D7BD1}"/>
              </a:ext>
            </a:extLst>
          </p:cNvPr>
          <p:cNvSpPr txBox="1"/>
          <p:nvPr/>
        </p:nvSpPr>
        <p:spPr>
          <a:xfrm>
            <a:off x="308572" y="233179"/>
            <a:ext cx="30161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s 4B,C </a:t>
            </a:r>
          </a:p>
        </p:txBody>
      </p:sp>
      <p:sp>
        <p:nvSpPr>
          <p:cNvPr id="6" name="Frame 5">
            <a:extLst>
              <a:ext uri="{FF2B5EF4-FFF2-40B4-BE49-F238E27FC236}">
                <a16:creationId xmlns:a16="http://schemas.microsoft.com/office/drawing/2014/main" id="{873ECDD7-E7D8-DF43-86EE-E01B26A34AF4}"/>
              </a:ext>
            </a:extLst>
          </p:cNvPr>
          <p:cNvSpPr/>
          <p:nvPr/>
        </p:nvSpPr>
        <p:spPr>
          <a:xfrm>
            <a:off x="753093" y="1866992"/>
            <a:ext cx="1306286" cy="2030681"/>
          </a:xfrm>
          <a:prstGeom prst="fram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7" name="Frame 6">
            <a:extLst>
              <a:ext uri="{FF2B5EF4-FFF2-40B4-BE49-F238E27FC236}">
                <a16:creationId xmlns:a16="http://schemas.microsoft.com/office/drawing/2014/main" id="{78B33E46-EDBB-8440-A264-D773B7FE6C60}"/>
              </a:ext>
            </a:extLst>
          </p:cNvPr>
          <p:cNvSpPr/>
          <p:nvPr/>
        </p:nvSpPr>
        <p:spPr>
          <a:xfrm>
            <a:off x="2896096" y="1825424"/>
            <a:ext cx="1306286" cy="2030681"/>
          </a:xfrm>
          <a:prstGeom prst="fram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8" name="Frame 7">
            <a:extLst>
              <a:ext uri="{FF2B5EF4-FFF2-40B4-BE49-F238E27FC236}">
                <a16:creationId xmlns:a16="http://schemas.microsoft.com/office/drawing/2014/main" id="{226DA20A-46D1-7C44-B46A-EB14CF50663D}"/>
              </a:ext>
            </a:extLst>
          </p:cNvPr>
          <p:cNvSpPr/>
          <p:nvPr/>
        </p:nvSpPr>
        <p:spPr>
          <a:xfrm>
            <a:off x="4987143" y="1827035"/>
            <a:ext cx="1306286" cy="2030681"/>
          </a:xfrm>
          <a:prstGeom prst="fram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44030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82</TotalTime>
  <Words>261</Words>
  <Application>Microsoft Macintosh PowerPoint</Application>
  <PresentationFormat>On-screen Show (4:3)</PresentationFormat>
  <Paragraphs>65</Paragraphs>
  <Slides>30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0</vt:i4>
      </vt:variant>
    </vt:vector>
  </HeadingPairs>
  <TitlesOfParts>
    <vt:vector size="33" baseType="lpstr">
      <vt:lpstr>Arial</vt:lpstr>
      <vt:lpstr>Calibri</vt:lpstr>
      <vt:lpstr>Office Theme</vt:lpstr>
      <vt:lpstr>Western Blots</vt:lpstr>
      <vt:lpstr>Ponceau patient 8 03.29.2017</vt:lpstr>
      <vt:lpstr>Patient 8 STAT1 + actin 15 mcg 03.30.2016</vt:lpstr>
      <vt:lpstr>Patient 8 STAT1 15 mcg 03.30.2016</vt:lpstr>
      <vt:lpstr>Patient 8 pSTAT1 + actin 15 mcg 03.31.2016</vt:lpstr>
      <vt:lpstr>Ponceau Patient 1 06.23.2016</vt:lpstr>
      <vt:lpstr>Patient 1 pSTAT1+ Beta actin 10 mcg 06.24.2016</vt:lpstr>
      <vt:lpstr>Patient 1 pSTAT1 10 mcg 06.24.2016</vt:lpstr>
      <vt:lpstr>Patient 1 Beta actin 10 mcg 06.24.2016</vt:lpstr>
      <vt:lpstr>Patient 1 STAT1 10 mcg 07.6.2016</vt:lpstr>
      <vt:lpstr>Ponceau patient 6 06.29.2016</vt:lpstr>
      <vt:lpstr>Patient 6 pSTAT1+ Beta actin 10 mcg 06.30.2016</vt:lpstr>
      <vt:lpstr>Patient 6 beta actin 10 mcg 06.30.2016</vt:lpstr>
      <vt:lpstr>Patient 6 STAT1 10 mcg 06.30.2016</vt:lpstr>
      <vt:lpstr>Patient 9 STAT1</vt:lpstr>
      <vt:lpstr>Patient 9 actin </vt:lpstr>
      <vt:lpstr>Patient 9 pSTAT1</vt:lpstr>
      <vt:lpstr>Patient 5 – 02.10.2017  STAT1 Cell Signaling 95</vt:lpstr>
      <vt:lpstr>Patient 5 – 02.10.2017  BA</vt:lpstr>
      <vt:lpstr>Patient 5 – 02.10.2017  membrane B - pSTAT1</vt:lpstr>
      <vt:lpstr>Patient 5 – 02.15.2017  STAT1 Cell Signaling 94</vt:lpstr>
      <vt:lpstr>Patient 5 – 02.15.2017  BA</vt:lpstr>
      <vt:lpstr>Patient 5 – 02.17.2017  STAT1 Cell Signaling 9172</vt:lpstr>
      <vt:lpstr>Patient 5 – 02.17.2017  BA</vt:lpstr>
      <vt:lpstr>Patient 5 – 02.17.2017  STAT1 BD mouse</vt:lpstr>
      <vt:lpstr>Patient 5 – 02.17.2017  BA</vt:lpstr>
      <vt:lpstr>STAT1 titration 1.19.2017</vt:lpstr>
      <vt:lpstr>STAT1 titration 1.20.2017</vt:lpstr>
      <vt:lpstr>STAT1 titration 1.20.2017</vt:lpstr>
      <vt:lpstr>Beta actin titration 3.25.2016</vt:lpstr>
    </vt:vector>
  </TitlesOfParts>
  <Company>NIH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fer Zimmerman</dc:creator>
  <cp:lastModifiedBy>Zimmerman, Ofer (NIH/NIAID) [V]</cp:lastModifiedBy>
  <cp:revision>87</cp:revision>
  <cp:lastPrinted>2017-02-22T20:15:27Z</cp:lastPrinted>
  <dcterms:created xsi:type="dcterms:W3CDTF">2017-01-15T00:56:48Z</dcterms:created>
  <dcterms:modified xsi:type="dcterms:W3CDTF">2019-04-02T00:36:13Z</dcterms:modified>
</cp:coreProperties>
</file>